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EE5B2-DBAD-4C56-87A1-97CD6A534E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14FDD-D718-4827-865E-BC7D1C6D7C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BD8F4-4A02-4142-A8D1-1AC1A0B064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B51C7-F13A-462A-BE61-EF5972F15F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FC405-23DA-40AC-B996-89633273F4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62183-06E4-4E67-B3A5-764AB8C750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F9348-C3E0-41C1-A649-E096FA694C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C7590-894A-4A9F-9D77-854B1C20F9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864D1-4B95-4610-AD0C-732BF3A0DF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8AF43-3AA5-4795-88F8-F2B974D76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DF98A-C328-416E-8120-47F35AB388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487DD-76E4-44B5-846C-C3B5135972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5F0A16-C83D-4DB3-BC25-BB5F72D62855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http://www.cbs.dtu.dk/services/TMHMM-2.0/tmp/TMHMM_1157/WEBSEQUENCE.gif"/>
          <p:cNvPicPr/>
          <p:nvPr/>
        </p:nvPicPr>
        <p:blipFill>
          <a:blip r:embed="rId1"/>
          <a:stretch/>
        </p:blipFill>
        <p:spPr>
          <a:xfrm>
            <a:off x="963720" y="1557360"/>
            <a:ext cx="6762600" cy="3333600"/>
          </a:xfrm>
          <a:prstGeom prst="rect">
            <a:avLst/>
          </a:prstGeom>
          <a:ln w="0">
            <a:noFill/>
          </a:ln>
        </p:spPr>
      </p:pic>
      <p:sp>
        <p:nvSpPr>
          <p:cNvPr id="42" name="1 Rectángulo"/>
          <p:cNvSpPr/>
          <p:nvPr/>
        </p:nvSpPr>
        <p:spPr>
          <a:xfrm>
            <a:off x="1835280" y="5157720"/>
            <a:ext cx="5832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WEBSEQUENCE Length: 4668 # WEBSEQUENCE Number of predicted TMHs: 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WEBSEQUENCE Exp number of AAs in TMHs: 0.47907999999999999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WEBSEQUENCE Exp number, first 60 AAs: 0.1592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WEBSEQUENCE Total prob of N-in: 0.01130 WEBSEQUENCE TMHMM2.0 outside 1 466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2 CuadroTexto"/>
          <p:cNvSpPr/>
          <p:nvPr/>
        </p:nvSpPr>
        <p:spPr>
          <a:xfrm>
            <a:off x="3924360" y="907920"/>
            <a:ext cx="14396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ZnC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Calibri"/>
              </a:rPr>
              <a:t>LinJ.36.42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2 CuadroTexto"/>
          <p:cNvSpPr/>
          <p:nvPr/>
        </p:nvSpPr>
        <p:spPr>
          <a:xfrm>
            <a:off x="1476360" y="260280"/>
            <a:ext cx="748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S1 Fig.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ZnCP transmembrane domain prediction with TMHMM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4T06:01:27Z</dcterms:created>
  <dc:creator>pedro alcolea</dc:creator>
  <dc:description/>
  <dc:language>en-US</dc:language>
  <cp:lastModifiedBy>Propietario</cp:lastModifiedBy>
  <dcterms:modified xsi:type="dcterms:W3CDTF">2016-03-29T15:31:25Z</dcterms:modified>
  <cp:revision>4</cp:revision>
  <dc:subject/>
  <dc:title>Presentación de PowerPoint</dc:title>
</cp:coreProperties>
</file>